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52" r:id="rId2"/>
    <p:sldId id="353" r:id="rId3"/>
    <p:sldId id="354" r:id="rId4"/>
  </p:sldIdLst>
  <p:sldSz cx="9144000" cy="6858000" type="screen4x3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1FE"/>
    <a:srgbClr val="E2F8FA"/>
    <a:srgbClr val="0086EA"/>
    <a:srgbClr val="64F2BC"/>
    <a:srgbClr val="87F5CB"/>
    <a:srgbClr val="8EF6CE"/>
    <a:srgbClr val="DEA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85" autoAdjust="0"/>
    <p:restoredTop sz="94651" autoAdjust="0"/>
  </p:normalViewPr>
  <p:slideViewPr>
    <p:cSldViewPr>
      <p:cViewPr>
        <p:scale>
          <a:sx n="100" d="100"/>
          <a:sy n="100" d="100"/>
        </p:scale>
        <p:origin x="-2304" y="-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A23737-2CB6-4656-96B2-15978C87A7EB}" type="datetimeFigureOut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1CC4D3-4937-44D5-B8E6-A5D419BE01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030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A5BDE-389E-4A33-9932-7AC22ABFCF2A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0188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1ECC0-54C2-4919-A9A8-7C5D8CDEF3B7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7109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B83BE-523A-4A78-98EC-785C608F0D5B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1978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8700-D71B-4D61-BD34-EB0F942598FF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210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5550E-C303-40C7-BA75-736E040D8D9F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9935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48520-9D19-49DD-A0E6-8C731806272C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315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9C64A-608C-4619-9060-2A478B48BB4F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8267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917AF-E63B-49F1-BCEB-0F18EE7B16EA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498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DB736-B3E6-4C34-907F-10BC1DD2E959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0861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9354A-82F3-47F5-B6F1-F4A047C58B51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636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732A-0576-43E8-B614-3E8AFC50F493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809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027B8-0E0F-4087-A725-64A4C7E09B39}" type="datetime1">
              <a:rPr kumimoji="1" lang="ja-JP" altLang="en-US" smtClean="0"/>
              <a:pPr/>
              <a:t>2017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5FFF73-BADD-4BA3-8A51-82401649CF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6082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5225" y="980728"/>
            <a:ext cx="6499103" cy="4492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3825188" y="5134201"/>
            <a:ext cx="14286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3242367"/>
            <a:ext cx="937779" cy="8016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032907"/>
              </p:ext>
            </p:extLst>
          </p:nvPr>
        </p:nvGraphicFramePr>
        <p:xfrm>
          <a:off x="135507" y="5400747"/>
          <a:ext cx="6572079" cy="836565"/>
        </p:xfrm>
        <a:graphic>
          <a:graphicData uri="http://schemas.openxmlformats.org/drawingml/2006/table">
            <a:tbl>
              <a:tblPr/>
              <a:tblGrid>
                <a:gridCol w="2227767"/>
                <a:gridCol w="104682"/>
                <a:gridCol w="706605"/>
                <a:gridCol w="706605"/>
                <a:gridCol w="706605"/>
                <a:gridCol w="706605"/>
                <a:gridCol w="706605"/>
                <a:gridCol w="706605"/>
              </a:tblGrid>
              <a:tr h="278855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s at risk: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855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2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   (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72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78855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 (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338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6" name="テキスト ボックス 15"/>
          <p:cNvSpPr txBox="1"/>
          <p:nvPr/>
        </p:nvSpPr>
        <p:spPr>
          <a:xfrm rot="16200000">
            <a:off x="-642871" y="2676176"/>
            <a:ext cx="3647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bability of renal survival 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35551" y="188640"/>
            <a:ext cx="2104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ea typeface="AR P丸ゴシック体M" panose="020B0600010101010101" pitchFamily="50" charset="-128"/>
                <a:cs typeface="Arial" panose="020B0604020202020204" pitchFamily="34" charset="0"/>
              </a:rPr>
              <a:t>Supplemental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 eh.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771799" y="3212976"/>
            <a:ext cx="1798923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PKD2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mutation</a:t>
            </a:r>
            <a:endParaRPr kumimoji="1" lang="en-US" altLang="ja-JP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PKD1</a:t>
            </a: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5283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8863" y="960980"/>
            <a:ext cx="6375686" cy="44067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4151421" y="4941168"/>
            <a:ext cx="14286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285784" y="2722422"/>
            <a:ext cx="36471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bability of renal survival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3403158"/>
            <a:ext cx="864096" cy="7717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0990856"/>
              </p:ext>
            </p:extLst>
          </p:nvPr>
        </p:nvGraphicFramePr>
        <p:xfrm>
          <a:off x="-36512" y="5157192"/>
          <a:ext cx="6780759" cy="1107124"/>
        </p:xfrm>
        <a:graphic>
          <a:graphicData uri="http://schemas.openxmlformats.org/drawingml/2006/table">
            <a:tbl>
              <a:tblPr/>
              <a:tblGrid>
                <a:gridCol w="2278335"/>
                <a:gridCol w="108492"/>
                <a:gridCol w="732322"/>
                <a:gridCol w="732322"/>
                <a:gridCol w="732322"/>
                <a:gridCol w="732322"/>
                <a:gridCol w="732322"/>
                <a:gridCol w="732322"/>
              </a:tblGrid>
              <a:tr h="276781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s at risk: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781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G3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 = 59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76781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G2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 = 75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6781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G1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 = 204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2843808" y="3343925"/>
            <a:ext cx="792088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fontAlgn="ctr"/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SG3</a:t>
            </a:r>
            <a:endParaRPr lang="ja-JP" altLang="ja-JP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altLang="ja-JP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SG2</a:t>
            </a:r>
            <a:endParaRPr lang="ja-JP" altLang="ja-JP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altLang="ja-JP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SG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35551" y="188640"/>
            <a:ext cx="18161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 eh.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2737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Rectangle 2"/>
          <p:cNvSpPr>
            <a:spLocks noChangeArrowheads="1"/>
          </p:cNvSpPr>
          <p:nvPr/>
        </p:nvSpPr>
        <p:spPr bwMode="auto">
          <a:xfrm>
            <a:off x="864927" y="4317833"/>
            <a:ext cx="7832327" cy="105795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68" name="AutoShape 3"/>
          <p:cNvSpPr>
            <a:spLocks noChangeArrowheads="1"/>
          </p:cNvSpPr>
          <p:nvPr/>
        </p:nvSpPr>
        <p:spPr bwMode="auto">
          <a:xfrm>
            <a:off x="1575823" y="413902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69" name="AutoShape 4"/>
          <p:cNvSpPr>
            <a:spLocks noChangeArrowheads="1"/>
          </p:cNvSpPr>
          <p:nvPr/>
        </p:nvSpPr>
        <p:spPr bwMode="auto">
          <a:xfrm>
            <a:off x="1764356" y="414051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70" name="AutoShape 5"/>
          <p:cNvSpPr>
            <a:spLocks noChangeArrowheads="1"/>
          </p:cNvSpPr>
          <p:nvPr/>
        </p:nvSpPr>
        <p:spPr bwMode="auto">
          <a:xfrm>
            <a:off x="1952890" y="414200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71" name="AutoShape 6"/>
          <p:cNvSpPr>
            <a:spLocks noChangeArrowheads="1"/>
          </p:cNvSpPr>
          <p:nvPr/>
        </p:nvSpPr>
        <p:spPr bwMode="auto">
          <a:xfrm>
            <a:off x="2141423" y="413902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72" name="AutoShape 7"/>
          <p:cNvSpPr>
            <a:spLocks noChangeArrowheads="1"/>
          </p:cNvSpPr>
          <p:nvPr/>
        </p:nvSpPr>
        <p:spPr bwMode="auto">
          <a:xfrm>
            <a:off x="2323125" y="414051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73" name="AutoShape 8"/>
          <p:cNvSpPr>
            <a:spLocks noChangeArrowheads="1"/>
          </p:cNvSpPr>
          <p:nvPr/>
        </p:nvSpPr>
        <p:spPr bwMode="auto">
          <a:xfrm>
            <a:off x="2518489" y="414945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74" name="AutoShape 9"/>
          <p:cNvSpPr>
            <a:spLocks noChangeArrowheads="1"/>
          </p:cNvSpPr>
          <p:nvPr/>
        </p:nvSpPr>
        <p:spPr bwMode="auto">
          <a:xfrm>
            <a:off x="3012566" y="414051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39" name="AutoShape 10"/>
          <p:cNvSpPr>
            <a:spLocks noChangeArrowheads="1"/>
          </p:cNvSpPr>
          <p:nvPr/>
        </p:nvSpPr>
        <p:spPr bwMode="auto">
          <a:xfrm>
            <a:off x="3216128" y="414200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0" name="AutoShape 11"/>
          <p:cNvSpPr>
            <a:spLocks noChangeArrowheads="1"/>
          </p:cNvSpPr>
          <p:nvPr/>
        </p:nvSpPr>
        <p:spPr bwMode="auto">
          <a:xfrm>
            <a:off x="3397830" y="414349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1" name="AutoShape 12"/>
          <p:cNvSpPr>
            <a:spLocks noChangeArrowheads="1"/>
          </p:cNvSpPr>
          <p:nvPr/>
        </p:nvSpPr>
        <p:spPr bwMode="auto">
          <a:xfrm>
            <a:off x="3590462" y="414498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2" name="AutoShape 13"/>
          <p:cNvSpPr>
            <a:spLocks noChangeArrowheads="1"/>
          </p:cNvSpPr>
          <p:nvPr/>
        </p:nvSpPr>
        <p:spPr bwMode="auto">
          <a:xfrm>
            <a:off x="3783094" y="4146474"/>
            <a:ext cx="109295" cy="411260"/>
          </a:xfrm>
          <a:prstGeom prst="can">
            <a:avLst>
              <a:gd name="adj" fmla="val 86250"/>
            </a:avLst>
          </a:prstGeom>
          <a:solidFill>
            <a:srgbClr val="519CD5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3" name="AutoShape 14"/>
          <p:cNvSpPr>
            <a:spLocks noChangeArrowheads="1"/>
          </p:cNvSpPr>
          <p:nvPr/>
        </p:nvSpPr>
        <p:spPr bwMode="auto">
          <a:xfrm>
            <a:off x="1806708" y="4060050"/>
            <a:ext cx="203561" cy="238412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180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4" name="AutoShape 15"/>
          <p:cNvSpPr>
            <a:spLocks noChangeArrowheads="1"/>
          </p:cNvSpPr>
          <p:nvPr/>
        </p:nvSpPr>
        <p:spPr bwMode="auto">
          <a:xfrm flipV="1">
            <a:off x="1648231" y="4453429"/>
            <a:ext cx="202195" cy="222021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713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5" name="AutoShape 16"/>
          <p:cNvSpPr>
            <a:spLocks noChangeArrowheads="1"/>
          </p:cNvSpPr>
          <p:nvPr/>
        </p:nvSpPr>
        <p:spPr bwMode="auto">
          <a:xfrm flipV="1">
            <a:off x="2019833" y="4405747"/>
            <a:ext cx="195364" cy="37251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763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6" name="AutoShape 17"/>
          <p:cNvSpPr>
            <a:spLocks noChangeArrowheads="1"/>
          </p:cNvSpPr>
          <p:nvPr/>
        </p:nvSpPr>
        <p:spPr bwMode="auto">
          <a:xfrm flipV="1">
            <a:off x="2375040" y="4407237"/>
            <a:ext cx="195364" cy="317385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735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7" name="AutoShape 18"/>
          <p:cNvSpPr>
            <a:spLocks noChangeArrowheads="1"/>
          </p:cNvSpPr>
          <p:nvPr/>
        </p:nvSpPr>
        <p:spPr bwMode="auto">
          <a:xfrm>
            <a:off x="2190606" y="4054090"/>
            <a:ext cx="203561" cy="238412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180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8" name="AutoShape 19"/>
          <p:cNvSpPr>
            <a:spLocks noChangeArrowheads="1"/>
          </p:cNvSpPr>
          <p:nvPr/>
        </p:nvSpPr>
        <p:spPr bwMode="auto">
          <a:xfrm flipV="1">
            <a:off x="3071312" y="4477270"/>
            <a:ext cx="202195" cy="16688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643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49" name="AutoShape 20"/>
          <p:cNvSpPr>
            <a:spLocks noChangeArrowheads="1"/>
          </p:cNvSpPr>
          <p:nvPr/>
        </p:nvSpPr>
        <p:spPr bwMode="auto">
          <a:xfrm flipV="1">
            <a:off x="3444280" y="4411707"/>
            <a:ext cx="202195" cy="326326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764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50" name="AutoShape 21"/>
          <p:cNvSpPr>
            <a:spLocks noChangeArrowheads="1"/>
          </p:cNvSpPr>
          <p:nvPr/>
        </p:nvSpPr>
        <p:spPr bwMode="auto">
          <a:xfrm>
            <a:off x="2576754" y="3760546"/>
            <a:ext cx="491824" cy="77781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145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51" name="AutoShape 22"/>
          <p:cNvSpPr>
            <a:spLocks noChangeArrowheads="1"/>
          </p:cNvSpPr>
          <p:nvPr/>
        </p:nvSpPr>
        <p:spPr bwMode="auto">
          <a:xfrm>
            <a:off x="3239353" y="4104752"/>
            <a:ext cx="203561" cy="16688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064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52" name="AutoShape 23"/>
          <p:cNvSpPr>
            <a:spLocks noChangeArrowheads="1"/>
          </p:cNvSpPr>
          <p:nvPr/>
        </p:nvSpPr>
        <p:spPr bwMode="auto">
          <a:xfrm>
            <a:off x="3632813" y="4058560"/>
            <a:ext cx="203561" cy="247352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108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grpSp>
        <p:nvGrpSpPr>
          <p:cNvPr id="153" name="Group 24"/>
          <p:cNvGrpSpPr>
            <a:grpSpLocks/>
          </p:cNvGrpSpPr>
          <p:nvPr/>
        </p:nvGrpSpPr>
        <p:grpSpPr bwMode="auto">
          <a:xfrm>
            <a:off x="3819981" y="4557734"/>
            <a:ext cx="1092946" cy="925335"/>
            <a:chOff x="2501" y="2614"/>
            <a:chExt cx="800" cy="621"/>
          </a:xfrm>
        </p:grpSpPr>
        <p:sp>
          <p:nvSpPr>
            <p:cNvPr id="154" name="Freeform 25"/>
            <p:cNvSpPr>
              <a:spLocks/>
            </p:cNvSpPr>
            <p:nvPr/>
          </p:nvSpPr>
          <p:spPr bwMode="auto">
            <a:xfrm>
              <a:off x="2501" y="2614"/>
              <a:ext cx="384" cy="347"/>
            </a:xfrm>
            <a:custGeom>
              <a:avLst/>
              <a:gdLst>
                <a:gd name="T0" fmla="*/ 0 w 384"/>
                <a:gd name="T1" fmla="*/ 0 h 347"/>
                <a:gd name="T2" fmla="*/ 32 w 384"/>
                <a:gd name="T3" fmla="*/ 107 h 347"/>
                <a:gd name="T4" fmla="*/ 118 w 384"/>
                <a:gd name="T5" fmla="*/ 213 h 347"/>
                <a:gd name="T6" fmla="*/ 267 w 384"/>
                <a:gd name="T7" fmla="*/ 293 h 347"/>
                <a:gd name="T8" fmla="*/ 384 w 384"/>
                <a:gd name="T9" fmla="*/ 347 h 34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84"/>
                <a:gd name="T16" fmla="*/ 0 h 347"/>
                <a:gd name="T17" fmla="*/ 384 w 384"/>
                <a:gd name="T18" fmla="*/ 347 h 34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84" h="347">
                  <a:moveTo>
                    <a:pt x="0" y="0"/>
                  </a:moveTo>
                  <a:cubicBezTo>
                    <a:pt x="6" y="36"/>
                    <a:pt x="12" y="72"/>
                    <a:pt x="32" y="107"/>
                  </a:cubicBezTo>
                  <a:cubicBezTo>
                    <a:pt x="52" y="142"/>
                    <a:pt x="79" y="182"/>
                    <a:pt x="118" y="213"/>
                  </a:cubicBezTo>
                  <a:cubicBezTo>
                    <a:pt x="157" y="244"/>
                    <a:pt x="223" y="271"/>
                    <a:pt x="267" y="293"/>
                  </a:cubicBezTo>
                  <a:cubicBezTo>
                    <a:pt x="311" y="315"/>
                    <a:pt x="365" y="338"/>
                    <a:pt x="384" y="347"/>
                  </a:cubicBezTo>
                </a:path>
              </a:pathLst>
            </a:cu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>
              <a:lvl1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1pPr>
              <a:lvl2pPr marL="37931725" indent="-37474525"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2pPr>
              <a:lvl3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3pPr>
              <a:lvl4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4pPr>
              <a:lvl5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9pPr>
            </a:lstStyle>
            <a:p>
              <a:endParaRPr lang="ja-JP" altLang="en-US"/>
            </a:p>
          </p:txBody>
        </p:sp>
        <p:sp>
          <p:nvSpPr>
            <p:cNvPr id="155" name="Freeform 26"/>
            <p:cNvSpPr>
              <a:spLocks/>
            </p:cNvSpPr>
            <p:nvPr/>
          </p:nvSpPr>
          <p:spPr bwMode="auto">
            <a:xfrm rot="-1495539">
              <a:off x="2922" y="2889"/>
              <a:ext cx="180" cy="295"/>
            </a:xfrm>
            <a:custGeom>
              <a:avLst/>
              <a:gdLst>
                <a:gd name="T0" fmla="*/ 0 w 180"/>
                <a:gd name="T1" fmla="*/ 28 h 295"/>
                <a:gd name="T2" fmla="*/ 48 w 180"/>
                <a:gd name="T3" fmla="*/ 39 h 295"/>
                <a:gd name="T4" fmla="*/ 48 w 180"/>
                <a:gd name="T5" fmla="*/ 12 h 295"/>
                <a:gd name="T6" fmla="*/ 21 w 180"/>
                <a:gd name="T7" fmla="*/ 55 h 295"/>
                <a:gd name="T8" fmla="*/ 59 w 180"/>
                <a:gd name="T9" fmla="*/ 103 h 295"/>
                <a:gd name="T10" fmla="*/ 107 w 180"/>
                <a:gd name="T11" fmla="*/ 71 h 295"/>
                <a:gd name="T12" fmla="*/ 53 w 180"/>
                <a:gd name="T13" fmla="*/ 108 h 295"/>
                <a:gd name="T14" fmla="*/ 112 w 180"/>
                <a:gd name="T15" fmla="*/ 145 h 295"/>
                <a:gd name="T16" fmla="*/ 112 w 180"/>
                <a:gd name="T17" fmla="*/ 124 h 295"/>
                <a:gd name="T18" fmla="*/ 75 w 180"/>
                <a:gd name="T19" fmla="*/ 172 h 295"/>
                <a:gd name="T20" fmla="*/ 112 w 180"/>
                <a:gd name="T21" fmla="*/ 204 h 295"/>
                <a:gd name="T22" fmla="*/ 155 w 180"/>
                <a:gd name="T23" fmla="*/ 199 h 295"/>
                <a:gd name="T24" fmla="*/ 165 w 180"/>
                <a:gd name="T25" fmla="*/ 183 h 295"/>
                <a:gd name="T26" fmla="*/ 123 w 180"/>
                <a:gd name="T27" fmla="*/ 188 h 295"/>
                <a:gd name="T28" fmla="*/ 107 w 180"/>
                <a:gd name="T29" fmla="*/ 247 h 295"/>
                <a:gd name="T30" fmla="*/ 139 w 180"/>
                <a:gd name="T31" fmla="*/ 263 h 295"/>
                <a:gd name="T32" fmla="*/ 171 w 180"/>
                <a:gd name="T33" fmla="*/ 252 h 295"/>
                <a:gd name="T34" fmla="*/ 176 w 180"/>
                <a:gd name="T35" fmla="*/ 236 h 295"/>
                <a:gd name="T36" fmla="*/ 149 w 180"/>
                <a:gd name="T37" fmla="*/ 241 h 295"/>
                <a:gd name="T38" fmla="*/ 117 w 180"/>
                <a:gd name="T39" fmla="*/ 279 h 295"/>
                <a:gd name="T40" fmla="*/ 123 w 180"/>
                <a:gd name="T41" fmla="*/ 295 h 29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180"/>
                <a:gd name="T64" fmla="*/ 0 h 295"/>
                <a:gd name="T65" fmla="*/ 180 w 180"/>
                <a:gd name="T66" fmla="*/ 295 h 295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180" h="295">
                  <a:moveTo>
                    <a:pt x="0" y="28"/>
                  </a:moveTo>
                  <a:cubicBezTo>
                    <a:pt x="18" y="41"/>
                    <a:pt x="25" y="45"/>
                    <a:pt x="48" y="39"/>
                  </a:cubicBezTo>
                  <a:cubicBezTo>
                    <a:pt x="57" y="25"/>
                    <a:pt x="84" y="0"/>
                    <a:pt x="48" y="12"/>
                  </a:cubicBezTo>
                  <a:cubicBezTo>
                    <a:pt x="28" y="25"/>
                    <a:pt x="28" y="33"/>
                    <a:pt x="21" y="55"/>
                  </a:cubicBezTo>
                  <a:cubicBezTo>
                    <a:pt x="28" y="97"/>
                    <a:pt x="29" y="82"/>
                    <a:pt x="59" y="103"/>
                  </a:cubicBezTo>
                  <a:cubicBezTo>
                    <a:pt x="83" y="96"/>
                    <a:pt x="92" y="91"/>
                    <a:pt x="107" y="71"/>
                  </a:cubicBezTo>
                  <a:cubicBezTo>
                    <a:pt x="80" y="32"/>
                    <a:pt x="62" y="82"/>
                    <a:pt x="53" y="108"/>
                  </a:cubicBezTo>
                  <a:cubicBezTo>
                    <a:pt x="62" y="160"/>
                    <a:pt x="51" y="158"/>
                    <a:pt x="112" y="145"/>
                  </a:cubicBezTo>
                  <a:cubicBezTo>
                    <a:pt x="126" y="136"/>
                    <a:pt x="160" y="112"/>
                    <a:pt x="112" y="124"/>
                  </a:cubicBezTo>
                  <a:cubicBezTo>
                    <a:pt x="87" y="136"/>
                    <a:pt x="83" y="146"/>
                    <a:pt x="75" y="172"/>
                  </a:cubicBezTo>
                  <a:cubicBezTo>
                    <a:pt x="81" y="193"/>
                    <a:pt x="90" y="197"/>
                    <a:pt x="112" y="204"/>
                  </a:cubicBezTo>
                  <a:cubicBezTo>
                    <a:pt x="126" y="202"/>
                    <a:pt x="141" y="204"/>
                    <a:pt x="155" y="199"/>
                  </a:cubicBezTo>
                  <a:cubicBezTo>
                    <a:pt x="160" y="196"/>
                    <a:pt x="170" y="185"/>
                    <a:pt x="165" y="183"/>
                  </a:cubicBezTo>
                  <a:cubicBezTo>
                    <a:pt x="151" y="178"/>
                    <a:pt x="137" y="186"/>
                    <a:pt x="123" y="188"/>
                  </a:cubicBezTo>
                  <a:cubicBezTo>
                    <a:pt x="96" y="196"/>
                    <a:pt x="93" y="218"/>
                    <a:pt x="107" y="247"/>
                  </a:cubicBezTo>
                  <a:cubicBezTo>
                    <a:pt x="109" y="253"/>
                    <a:pt x="133" y="260"/>
                    <a:pt x="139" y="263"/>
                  </a:cubicBezTo>
                  <a:cubicBezTo>
                    <a:pt x="149" y="259"/>
                    <a:pt x="161" y="258"/>
                    <a:pt x="171" y="252"/>
                  </a:cubicBezTo>
                  <a:cubicBezTo>
                    <a:pt x="175" y="248"/>
                    <a:pt x="180" y="238"/>
                    <a:pt x="176" y="236"/>
                  </a:cubicBezTo>
                  <a:cubicBezTo>
                    <a:pt x="167" y="231"/>
                    <a:pt x="158" y="239"/>
                    <a:pt x="149" y="241"/>
                  </a:cubicBezTo>
                  <a:cubicBezTo>
                    <a:pt x="127" y="248"/>
                    <a:pt x="124" y="258"/>
                    <a:pt x="117" y="279"/>
                  </a:cubicBezTo>
                  <a:cubicBezTo>
                    <a:pt x="119" y="284"/>
                    <a:pt x="123" y="295"/>
                    <a:pt x="123" y="295"/>
                  </a:cubicBezTo>
                </a:path>
              </a:pathLst>
            </a:cu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>
              <a:lvl1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1pPr>
              <a:lvl2pPr marL="37931725" indent="-37474525"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2pPr>
              <a:lvl3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3pPr>
              <a:lvl4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4pPr>
              <a:lvl5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9pPr>
            </a:lstStyle>
            <a:p>
              <a:endParaRPr lang="ja-JP" altLang="en-US"/>
            </a:p>
          </p:txBody>
        </p:sp>
        <p:sp>
          <p:nvSpPr>
            <p:cNvPr id="156" name="Freeform 27"/>
            <p:cNvSpPr>
              <a:spLocks/>
            </p:cNvSpPr>
            <p:nvPr/>
          </p:nvSpPr>
          <p:spPr bwMode="auto">
            <a:xfrm>
              <a:off x="3093" y="3152"/>
              <a:ext cx="208" cy="83"/>
            </a:xfrm>
            <a:custGeom>
              <a:avLst/>
              <a:gdLst>
                <a:gd name="T0" fmla="*/ 0 w 208"/>
                <a:gd name="T1" fmla="*/ 0 h 83"/>
                <a:gd name="T2" fmla="*/ 75 w 208"/>
                <a:gd name="T3" fmla="*/ 59 h 83"/>
                <a:gd name="T4" fmla="*/ 150 w 208"/>
                <a:gd name="T5" fmla="*/ 80 h 83"/>
                <a:gd name="T6" fmla="*/ 208 w 208"/>
                <a:gd name="T7" fmla="*/ 80 h 8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08"/>
                <a:gd name="T13" fmla="*/ 0 h 83"/>
                <a:gd name="T14" fmla="*/ 208 w 208"/>
                <a:gd name="T15" fmla="*/ 83 h 8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08" h="83">
                  <a:moveTo>
                    <a:pt x="0" y="0"/>
                  </a:moveTo>
                  <a:cubicBezTo>
                    <a:pt x="25" y="23"/>
                    <a:pt x="50" y="46"/>
                    <a:pt x="75" y="59"/>
                  </a:cubicBezTo>
                  <a:cubicBezTo>
                    <a:pt x="100" y="72"/>
                    <a:pt x="128" y="77"/>
                    <a:pt x="150" y="80"/>
                  </a:cubicBezTo>
                  <a:cubicBezTo>
                    <a:pt x="172" y="83"/>
                    <a:pt x="190" y="81"/>
                    <a:pt x="208" y="80"/>
                  </a:cubicBezTo>
                </a:path>
              </a:pathLst>
            </a:cu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>
              <a:lvl1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1pPr>
              <a:lvl2pPr marL="37931725" indent="-37474525"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2pPr>
              <a:lvl3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3pPr>
              <a:lvl4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4pPr>
              <a:lvl5pPr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3200">
                  <a:solidFill>
                    <a:schemeClr val="tx1"/>
                  </a:solidFill>
                  <a:latin typeface="Times" charset="0"/>
                  <a:ea typeface="Osaka" charset="-128"/>
                </a:defRPr>
              </a:lvl9pPr>
            </a:lstStyle>
            <a:p>
              <a:endParaRPr lang="ja-JP" altLang="en-US"/>
            </a:p>
          </p:txBody>
        </p:sp>
      </p:grpSp>
      <p:sp>
        <p:nvSpPr>
          <p:cNvPr id="157" name="Oval 28"/>
          <p:cNvSpPr>
            <a:spLocks noChangeArrowheads="1"/>
          </p:cNvSpPr>
          <p:nvPr/>
        </p:nvSpPr>
        <p:spPr bwMode="auto">
          <a:xfrm>
            <a:off x="1668724" y="4626278"/>
            <a:ext cx="131154" cy="56623"/>
          </a:xfrm>
          <a:prstGeom prst="ellipse">
            <a:avLst/>
          </a:prstGeom>
          <a:solidFill>
            <a:schemeClr val="accent1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58" name="Oval 59"/>
          <p:cNvSpPr>
            <a:spLocks noChangeArrowheads="1"/>
          </p:cNvSpPr>
          <p:nvPr/>
        </p:nvSpPr>
        <p:spPr bwMode="auto">
          <a:xfrm>
            <a:off x="1564894" y="4072475"/>
            <a:ext cx="166674" cy="105795"/>
          </a:xfrm>
          <a:prstGeom prst="ellipse">
            <a:avLst/>
          </a:prstGeom>
          <a:solidFill>
            <a:srgbClr val="E80000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59" name="AutoShape 60"/>
          <p:cNvSpPr>
            <a:spLocks noChangeArrowheads="1"/>
          </p:cNvSpPr>
          <p:nvPr/>
        </p:nvSpPr>
        <p:spPr bwMode="auto">
          <a:xfrm>
            <a:off x="5415682" y="4146474"/>
            <a:ext cx="109295" cy="411260"/>
          </a:xfrm>
          <a:prstGeom prst="can">
            <a:avLst>
              <a:gd name="adj" fmla="val 86250"/>
            </a:avLst>
          </a:prstGeom>
          <a:solidFill>
            <a:srgbClr val="4BE643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0" name="AutoShape 61"/>
          <p:cNvSpPr>
            <a:spLocks noChangeArrowheads="1"/>
          </p:cNvSpPr>
          <p:nvPr/>
        </p:nvSpPr>
        <p:spPr bwMode="auto">
          <a:xfrm>
            <a:off x="5929367" y="4146474"/>
            <a:ext cx="109295" cy="411260"/>
          </a:xfrm>
          <a:prstGeom prst="can">
            <a:avLst>
              <a:gd name="adj" fmla="val 86250"/>
            </a:avLst>
          </a:prstGeom>
          <a:solidFill>
            <a:srgbClr val="4BE643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1" name="AutoShape 62"/>
          <p:cNvSpPr>
            <a:spLocks noChangeArrowheads="1"/>
          </p:cNvSpPr>
          <p:nvPr/>
        </p:nvSpPr>
        <p:spPr bwMode="auto">
          <a:xfrm>
            <a:off x="6137027" y="4146474"/>
            <a:ext cx="109295" cy="411260"/>
          </a:xfrm>
          <a:prstGeom prst="can">
            <a:avLst>
              <a:gd name="adj" fmla="val 86250"/>
            </a:avLst>
          </a:prstGeom>
          <a:solidFill>
            <a:srgbClr val="4BE643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2" name="AutoShape 63"/>
          <p:cNvSpPr>
            <a:spLocks noChangeArrowheads="1"/>
          </p:cNvSpPr>
          <p:nvPr/>
        </p:nvSpPr>
        <p:spPr bwMode="auto">
          <a:xfrm>
            <a:off x="6344687" y="4146474"/>
            <a:ext cx="109295" cy="411260"/>
          </a:xfrm>
          <a:prstGeom prst="can">
            <a:avLst>
              <a:gd name="adj" fmla="val 86250"/>
            </a:avLst>
          </a:prstGeom>
          <a:solidFill>
            <a:srgbClr val="4BE643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3" name="AutoShape 64"/>
          <p:cNvSpPr>
            <a:spLocks noChangeArrowheads="1"/>
          </p:cNvSpPr>
          <p:nvPr/>
        </p:nvSpPr>
        <p:spPr bwMode="auto">
          <a:xfrm>
            <a:off x="6552347" y="4146474"/>
            <a:ext cx="109295" cy="411260"/>
          </a:xfrm>
          <a:prstGeom prst="can">
            <a:avLst>
              <a:gd name="adj" fmla="val 86250"/>
            </a:avLst>
          </a:prstGeom>
          <a:solidFill>
            <a:srgbClr val="4BE643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4" name="AutoShape 65"/>
          <p:cNvSpPr>
            <a:spLocks noChangeArrowheads="1"/>
          </p:cNvSpPr>
          <p:nvPr/>
        </p:nvSpPr>
        <p:spPr bwMode="auto">
          <a:xfrm>
            <a:off x="6876256" y="4122633"/>
            <a:ext cx="109295" cy="411260"/>
          </a:xfrm>
          <a:prstGeom prst="can">
            <a:avLst>
              <a:gd name="adj" fmla="val 86250"/>
            </a:avLst>
          </a:prstGeom>
          <a:solidFill>
            <a:srgbClr val="4BE643"/>
          </a:solidFill>
          <a:ln w="9525">
            <a:solidFill>
              <a:schemeClr val="bg2"/>
            </a:solidFill>
            <a:round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5" name="AutoShape 66"/>
          <p:cNvSpPr>
            <a:spLocks noChangeArrowheads="1"/>
          </p:cNvSpPr>
          <p:nvPr/>
        </p:nvSpPr>
        <p:spPr bwMode="auto">
          <a:xfrm flipV="1">
            <a:off x="5967620" y="4501112"/>
            <a:ext cx="202195" cy="16688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643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6" name="AutoShape 67"/>
          <p:cNvSpPr>
            <a:spLocks noChangeArrowheads="1"/>
          </p:cNvSpPr>
          <p:nvPr/>
        </p:nvSpPr>
        <p:spPr bwMode="auto">
          <a:xfrm flipV="1">
            <a:off x="6393869" y="4489191"/>
            <a:ext cx="202195" cy="16688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643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64" y="12679"/>
                </a:moveTo>
                <a:cubicBezTo>
                  <a:pt x="55" y="12058"/>
                  <a:pt x="0" y="11430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430"/>
                  <a:pt x="21544" y="12058"/>
                  <a:pt x="21435" y="12679"/>
                </a:cubicBezTo>
                <a:cubicBezTo>
                  <a:pt x="21544" y="12058"/>
                  <a:pt x="21600" y="11430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430"/>
                  <a:pt x="55" y="12058"/>
                  <a:pt x="164" y="1267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7" name="AutoShape 68"/>
          <p:cNvSpPr>
            <a:spLocks noChangeArrowheads="1"/>
          </p:cNvSpPr>
          <p:nvPr/>
        </p:nvSpPr>
        <p:spPr bwMode="auto">
          <a:xfrm>
            <a:off x="6201237" y="4092832"/>
            <a:ext cx="203561" cy="166888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064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8" name="AutoShape 69"/>
          <p:cNvSpPr>
            <a:spLocks noChangeArrowheads="1"/>
          </p:cNvSpPr>
          <p:nvPr/>
        </p:nvSpPr>
        <p:spPr bwMode="auto">
          <a:xfrm>
            <a:off x="6594698" y="3699453"/>
            <a:ext cx="351932" cy="822520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9157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83" y="12139"/>
                </a:moveTo>
                <a:cubicBezTo>
                  <a:pt x="27" y="11695"/>
                  <a:pt x="0" y="11247"/>
                  <a:pt x="0" y="10800"/>
                </a:cubicBezTo>
                <a:cubicBezTo>
                  <a:pt x="0" y="4835"/>
                  <a:pt x="4835" y="0"/>
                  <a:pt x="10800" y="0"/>
                </a:cubicBezTo>
                <a:cubicBezTo>
                  <a:pt x="16764" y="0"/>
                  <a:pt x="21600" y="4835"/>
                  <a:pt x="21600" y="10800"/>
                </a:cubicBezTo>
                <a:cubicBezTo>
                  <a:pt x="21600" y="11247"/>
                  <a:pt x="21572" y="11695"/>
                  <a:pt x="21516" y="12139"/>
                </a:cubicBezTo>
                <a:cubicBezTo>
                  <a:pt x="21572" y="11695"/>
                  <a:pt x="21600" y="11247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0" y="11247"/>
                  <a:pt x="27" y="11695"/>
                  <a:pt x="83" y="12139"/>
                </a:cubicBezTo>
                <a:close/>
              </a:path>
            </a:pathLst>
          </a:custGeom>
          <a:solidFill>
            <a:schemeClr val="bg2"/>
          </a:solidFill>
          <a:ln w="19050">
            <a:solidFill>
              <a:schemeClr val="tx2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69" name="Freeform 70"/>
          <p:cNvSpPr>
            <a:spLocks/>
          </p:cNvSpPr>
          <p:nvPr/>
        </p:nvSpPr>
        <p:spPr bwMode="auto">
          <a:xfrm>
            <a:off x="6911777" y="4548794"/>
            <a:ext cx="624346" cy="555797"/>
          </a:xfrm>
          <a:custGeom>
            <a:avLst/>
            <a:gdLst>
              <a:gd name="T0" fmla="*/ 9 w 457"/>
              <a:gd name="T1" fmla="*/ 0 h 373"/>
              <a:gd name="T2" fmla="*/ 1 w 457"/>
              <a:gd name="T3" fmla="*/ 120 h 373"/>
              <a:gd name="T4" fmla="*/ 17 w 457"/>
              <a:gd name="T5" fmla="*/ 216 h 373"/>
              <a:gd name="T6" fmla="*/ 81 w 457"/>
              <a:gd name="T7" fmla="*/ 296 h 373"/>
              <a:gd name="T8" fmla="*/ 201 w 457"/>
              <a:gd name="T9" fmla="*/ 336 h 373"/>
              <a:gd name="T10" fmla="*/ 409 w 457"/>
              <a:gd name="T11" fmla="*/ 368 h 373"/>
              <a:gd name="T12" fmla="*/ 457 w 457"/>
              <a:gd name="T13" fmla="*/ 368 h 373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457"/>
              <a:gd name="T22" fmla="*/ 0 h 373"/>
              <a:gd name="T23" fmla="*/ 457 w 457"/>
              <a:gd name="T24" fmla="*/ 373 h 373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457" h="373">
                <a:moveTo>
                  <a:pt x="9" y="0"/>
                </a:moveTo>
                <a:cubicBezTo>
                  <a:pt x="4" y="42"/>
                  <a:pt x="0" y="84"/>
                  <a:pt x="1" y="120"/>
                </a:cubicBezTo>
                <a:cubicBezTo>
                  <a:pt x="2" y="156"/>
                  <a:pt x="4" y="187"/>
                  <a:pt x="17" y="216"/>
                </a:cubicBezTo>
                <a:cubicBezTo>
                  <a:pt x="30" y="245"/>
                  <a:pt x="50" y="276"/>
                  <a:pt x="81" y="296"/>
                </a:cubicBezTo>
                <a:cubicBezTo>
                  <a:pt x="112" y="316"/>
                  <a:pt x="146" y="324"/>
                  <a:pt x="201" y="336"/>
                </a:cubicBezTo>
                <a:cubicBezTo>
                  <a:pt x="256" y="348"/>
                  <a:pt x="366" y="363"/>
                  <a:pt x="409" y="368"/>
                </a:cubicBezTo>
                <a:cubicBezTo>
                  <a:pt x="452" y="373"/>
                  <a:pt x="454" y="370"/>
                  <a:pt x="457" y="368"/>
                </a:cubicBezTo>
              </a:path>
            </a:pathLst>
          </a:custGeom>
          <a:noFill/>
          <a:ln w="19050">
            <a:solidFill>
              <a:schemeClr val="tx2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70" name="Text Box 71"/>
          <p:cNvSpPr txBox="1">
            <a:spLocks noChangeArrowheads="1"/>
          </p:cNvSpPr>
          <p:nvPr/>
        </p:nvSpPr>
        <p:spPr bwMode="auto">
          <a:xfrm>
            <a:off x="2082392" y="2060848"/>
            <a:ext cx="63390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ja-JP" sz="1400" b="1" dirty="0"/>
              <a:t>NH</a:t>
            </a:r>
            <a:r>
              <a:rPr lang="en-US" altLang="ja-JP" sz="1400" b="1" baseline="-25000" dirty="0"/>
              <a:t>2</a:t>
            </a:r>
            <a:endParaRPr lang="en-US" altLang="ja-JP" sz="2000" dirty="0"/>
          </a:p>
        </p:txBody>
      </p:sp>
      <p:sp>
        <p:nvSpPr>
          <p:cNvPr id="171" name="Text Box 86"/>
          <p:cNvSpPr txBox="1">
            <a:spLocks noChangeArrowheads="1"/>
          </p:cNvSpPr>
          <p:nvPr/>
        </p:nvSpPr>
        <p:spPr bwMode="auto">
          <a:xfrm>
            <a:off x="805203" y="3935217"/>
            <a:ext cx="74246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ja-JP" sz="1400" b="1" dirty="0"/>
              <a:t>GPS</a:t>
            </a:r>
            <a:endParaRPr lang="en-US" altLang="ja-JP" sz="2000" dirty="0"/>
          </a:p>
        </p:txBody>
      </p:sp>
      <p:sp>
        <p:nvSpPr>
          <p:cNvPr id="172" name="Freeform 108"/>
          <p:cNvSpPr>
            <a:spLocks/>
          </p:cNvSpPr>
          <p:nvPr/>
        </p:nvSpPr>
        <p:spPr bwMode="auto">
          <a:xfrm>
            <a:off x="5487546" y="3833559"/>
            <a:ext cx="524614" cy="540896"/>
          </a:xfrm>
          <a:custGeom>
            <a:avLst/>
            <a:gdLst>
              <a:gd name="T0" fmla="*/ 0 w 384"/>
              <a:gd name="T1" fmla="*/ 248 h 363"/>
              <a:gd name="T2" fmla="*/ 16 w 384"/>
              <a:gd name="T3" fmla="*/ 96 h 363"/>
              <a:gd name="T4" fmla="*/ 48 w 384"/>
              <a:gd name="T5" fmla="*/ 24 h 363"/>
              <a:gd name="T6" fmla="*/ 104 w 384"/>
              <a:gd name="T7" fmla="*/ 16 h 363"/>
              <a:gd name="T8" fmla="*/ 120 w 384"/>
              <a:gd name="T9" fmla="*/ 88 h 363"/>
              <a:gd name="T10" fmla="*/ 128 w 384"/>
              <a:gd name="T11" fmla="*/ 144 h 363"/>
              <a:gd name="T12" fmla="*/ 128 w 384"/>
              <a:gd name="T13" fmla="*/ 232 h 363"/>
              <a:gd name="T14" fmla="*/ 144 w 384"/>
              <a:gd name="T15" fmla="*/ 312 h 363"/>
              <a:gd name="T16" fmla="*/ 176 w 384"/>
              <a:gd name="T17" fmla="*/ 360 h 363"/>
              <a:gd name="T18" fmla="*/ 224 w 384"/>
              <a:gd name="T19" fmla="*/ 328 h 363"/>
              <a:gd name="T20" fmla="*/ 240 w 384"/>
              <a:gd name="T21" fmla="*/ 264 h 363"/>
              <a:gd name="T22" fmla="*/ 240 w 384"/>
              <a:gd name="T23" fmla="*/ 216 h 363"/>
              <a:gd name="T24" fmla="*/ 240 w 384"/>
              <a:gd name="T25" fmla="*/ 160 h 363"/>
              <a:gd name="T26" fmla="*/ 240 w 384"/>
              <a:gd name="T27" fmla="*/ 88 h 363"/>
              <a:gd name="T28" fmla="*/ 264 w 384"/>
              <a:gd name="T29" fmla="*/ 24 h 363"/>
              <a:gd name="T30" fmla="*/ 304 w 384"/>
              <a:gd name="T31" fmla="*/ 0 h 363"/>
              <a:gd name="T32" fmla="*/ 344 w 384"/>
              <a:gd name="T33" fmla="*/ 24 h 363"/>
              <a:gd name="T34" fmla="*/ 368 w 384"/>
              <a:gd name="T35" fmla="*/ 96 h 363"/>
              <a:gd name="T36" fmla="*/ 376 w 384"/>
              <a:gd name="T37" fmla="*/ 152 h 363"/>
              <a:gd name="T38" fmla="*/ 376 w 384"/>
              <a:gd name="T39" fmla="*/ 200 h 363"/>
              <a:gd name="T40" fmla="*/ 384 w 384"/>
              <a:gd name="T41" fmla="*/ 248 h 363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w 384"/>
              <a:gd name="T64" fmla="*/ 0 h 363"/>
              <a:gd name="T65" fmla="*/ 384 w 384"/>
              <a:gd name="T66" fmla="*/ 363 h 363"/>
            </a:gdLst>
            <a:ahLst/>
            <a:cxnLst>
              <a:cxn ang="T42">
                <a:pos x="T0" y="T1"/>
              </a:cxn>
              <a:cxn ang="T43">
                <a:pos x="T2" y="T3"/>
              </a:cxn>
              <a:cxn ang="T44">
                <a:pos x="T4" y="T5"/>
              </a:cxn>
              <a:cxn ang="T45">
                <a:pos x="T6" y="T7"/>
              </a:cxn>
              <a:cxn ang="T46">
                <a:pos x="T8" y="T9"/>
              </a:cxn>
              <a:cxn ang="T47">
                <a:pos x="T10" y="T11"/>
              </a:cxn>
              <a:cxn ang="T48">
                <a:pos x="T12" y="T13"/>
              </a:cxn>
              <a:cxn ang="T49">
                <a:pos x="T14" y="T15"/>
              </a:cxn>
              <a:cxn ang="T50">
                <a:pos x="T16" y="T17"/>
              </a:cxn>
              <a:cxn ang="T51">
                <a:pos x="T18" y="T19"/>
              </a:cxn>
              <a:cxn ang="T52">
                <a:pos x="T20" y="T21"/>
              </a:cxn>
              <a:cxn ang="T53">
                <a:pos x="T22" y="T23"/>
              </a:cxn>
              <a:cxn ang="T54">
                <a:pos x="T24" y="T25"/>
              </a:cxn>
              <a:cxn ang="T55">
                <a:pos x="T26" y="T27"/>
              </a:cxn>
              <a:cxn ang="T56">
                <a:pos x="T28" y="T29"/>
              </a:cxn>
              <a:cxn ang="T57">
                <a:pos x="T30" y="T31"/>
              </a:cxn>
              <a:cxn ang="T58">
                <a:pos x="T32" y="T33"/>
              </a:cxn>
              <a:cxn ang="T59">
                <a:pos x="T34" y="T35"/>
              </a:cxn>
              <a:cxn ang="T60">
                <a:pos x="T36" y="T37"/>
              </a:cxn>
              <a:cxn ang="T61">
                <a:pos x="T38" y="T39"/>
              </a:cxn>
              <a:cxn ang="T62">
                <a:pos x="T40" y="T41"/>
              </a:cxn>
            </a:cxnLst>
            <a:rect l="T63" t="T64" r="T65" b="T66"/>
            <a:pathLst>
              <a:path w="384" h="363">
                <a:moveTo>
                  <a:pt x="0" y="248"/>
                </a:moveTo>
                <a:cubicBezTo>
                  <a:pt x="4" y="190"/>
                  <a:pt x="8" y="133"/>
                  <a:pt x="16" y="96"/>
                </a:cubicBezTo>
                <a:cubicBezTo>
                  <a:pt x="24" y="59"/>
                  <a:pt x="33" y="37"/>
                  <a:pt x="48" y="24"/>
                </a:cubicBezTo>
                <a:cubicBezTo>
                  <a:pt x="63" y="11"/>
                  <a:pt x="92" y="5"/>
                  <a:pt x="104" y="16"/>
                </a:cubicBezTo>
                <a:cubicBezTo>
                  <a:pt x="116" y="27"/>
                  <a:pt x="116" y="67"/>
                  <a:pt x="120" y="88"/>
                </a:cubicBezTo>
                <a:cubicBezTo>
                  <a:pt x="124" y="109"/>
                  <a:pt x="127" y="120"/>
                  <a:pt x="128" y="144"/>
                </a:cubicBezTo>
                <a:cubicBezTo>
                  <a:pt x="129" y="168"/>
                  <a:pt x="125" y="204"/>
                  <a:pt x="128" y="232"/>
                </a:cubicBezTo>
                <a:cubicBezTo>
                  <a:pt x="131" y="260"/>
                  <a:pt x="136" y="291"/>
                  <a:pt x="144" y="312"/>
                </a:cubicBezTo>
                <a:cubicBezTo>
                  <a:pt x="152" y="333"/>
                  <a:pt x="163" y="357"/>
                  <a:pt x="176" y="360"/>
                </a:cubicBezTo>
                <a:cubicBezTo>
                  <a:pt x="189" y="363"/>
                  <a:pt x="213" y="344"/>
                  <a:pt x="224" y="328"/>
                </a:cubicBezTo>
                <a:cubicBezTo>
                  <a:pt x="235" y="312"/>
                  <a:pt x="237" y="283"/>
                  <a:pt x="240" y="264"/>
                </a:cubicBezTo>
                <a:cubicBezTo>
                  <a:pt x="243" y="245"/>
                  <a:pt x="240" y="233"/>
                  <a:pt x="240" y="216"/>
                </a:cubicBezTo>
                <a:cubicBezTo>
                  <a:pt x="240" y="199"/>
                  <a:pt x="240" y="181"/>
                  <a:pt x="240" y="160"/>
                </a:cubicBezTo>
                <a:cubicBezTo>
                  <a:pt x="240" y="139"/>
                  <a:pt x="236" y="111"/>
                  <a:pt x="240" y="88"/>
                </a:cubicBezTo>
                <a:cubicBezTo>
                  <a:pt x="244" y="65"/>
                  <a:pt x="253" y="39"/>
                  <a:pt x="264" y="24"/>
                </a:cubicBezTo>
                <a:cubicBezTo>
                  <a:pt x="275" y="9"/>
                  <a:pt x="291" y="0"/>
                  <a:pt x="304" y="0"/>
                </a:cubicBezTo>
                <a:cubicBezTo>
                  <a:pt x="317" y="0"/>
                  <a:pt x="333" y="8"/>
                  <a:pt x="344" y="24"/>
                </a:cubicBezTo>
                <a:cubicBezTo>
                  <a:pt x="355" y="40"/>
                  <a:pt x="363" y="75"/>
                  <a:pt x="368" y="96"/>
                </a:cubicBezTo>
                <a:cubicBezTo>
                  <a:pt x="373" y="117"/>
                  <a:pt x="375" y="135"/>
                  <a:pt x="376" y="152"/>
                </a:cubicBezTo>
                <a:cubicBezTo>
                  <a:pt x="377" y="169"/>
                  <a:pt x="375" y="184"/>
                  <a:pt x="376" y="200"/>
                </a:cubicBezTo>
                <a:cubicBezTo>
                  <a:pt x="377" y="216"/>
                  <a:pt x="383" y="240"/>
                  <a:pt x="384" y="248"/>
                </a:cubicBezTo>
              </a:path>
            </a:pathLst>
          </a:custGeom>
          <a:noFill/>
          <a:ln w="19050">
            <a:solidFill>
              <a:schemeClr val="tx2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73" name="Text Box 111"/>
          <p:cNvSpPr txBox="1">
            <a:spLocks noChangeArrowheads="1"/>
          </p:cNvSpPr>
          <p:nvPr/>
        </p:nvSpPr>
        <p:spPr bwMode="auto">
          <a:xfrm>
            <a:off x="7547052" y="4966014"/>
            <a:ext cx="68719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ja-JP" sz="1400" b="1" dirty="0" smtClean="0"/>
              <a:t>NH</a:t>
            </a:r>
            <a:r>
              <a:rPr lang="en-US" altLang="ja-JP" sz="1400" b="1" baseline="-25000" dirty="0" smtClean="0"/>
              <a:t>2</a:t>
            </a:r>
            <a:endParaRPr lang="en-US" altLang="ja-JP" sz="2000" dirty="0"/>
          </a:p>
        </p:txBody>
      </p:sp>
      <p:sp>
        <p:nvSpPr>
          <p:cNvPr id="174" name="Text Box 112"/>
          <p:cNvSpPr txBox="1">
            <a:spLocks noChangeArrowheads="1"/>
          </p:cNvSpPr>
          <p:nvPr/>
        </p:nvSpPr>
        <p:spPr bwMode="auto">
          <a:xfrm>
            <a:off x="4906096" y="5204426"/>
            <a:ext cx="88665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ja-JP" sz="1400" dirty="0"/>
              <a:t>COOH</a:t>
            </a:r>
          </a:p>
        </p:txBody>
      </p:sp>
      <p:sp>
        <p:nvSpPr>
          <p:cNvPr id="175" name="Text Box 113"/>
          <p:cNvSpPr txBox="1">
            <a:spLocks noChangeArrowheads="1"/>
          </p:cNvSpPr>
          <p:nvPr/>
        </p:nvSpPr>
        <p:spPr bwMode="auto">
          <a:xfrm>
            <a:off x="4873308" y="5359393"/>
            <a:ext cx="7807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ja-JP" sz="1400" dirty="0"/>
              <a:t>COOH</a:t>
            </a:r>
          </a:p>
        </p:txBody>
      </p:sp>
      <p:sp>
        <p:nvSpPr>
          <p:cNvPr id="176" name="Freeform 114"/>
          <p:cNvSpPr>
            <a:spLocks/>
          </p:cNvSpPr>
          <p:nvPr/>
        </p:nvSpPr>
        <p:spPr bwMode="auto">
          <a:xfrm>
            <a:off x="4287215" y="4560714"/>
            <a:ext cx="1163988" cy="774838"/>
          </a:xfrm>
          <a:custGeom>
            <a:avLst/>
            <a:gdLst>
              <a:gd name="T0" fmla="*/ 845 w 852"/>
              <a:gd name="T1" fmla="*/ 0 h 520"/>
              <a:gd name="T2" fmla="*/ 845 w 852"/>
              <a:gd name="T3" fmla="*/ 80 h 520"/>
              <a:gd name="T4" fmla="*/ 805 w 852"/>
              <a:gd name="T5" fmla="*/ 112 h 520"/>
              <a:gd name="T6" fmla="*/ 701 w 852"/>
              <a:gd name="T7" fmla="*/ 152 h 520"/>
              <a:gd name="T8" fmla="*/ 541 w 852"/>
              <a:gd name="T9" fmla="*/ 160 h 520"/>
              <a:gd name="T10" fmla="*/ 317 w 852"/>
              <a:gd name="T11" fmla="*/ 160 h 520"/>
              <a:gd name="T12" fmla="*/ 189 w 852"/>
              <a:gd name="T13" fmla="*/ 168 h 520"/>
              <a:gd name="T14" fmla="*/ 69 w 852"/>
              <a:gd name="T15" fmla="*/ 208 h 520"/>
              <a:gd name="T16" fmla="*/ 5 w 852"/>
              <a:gd name="T17" fmla="*/ 240 h 520"/>
              <a:gd name="T18" fmla="*/ 37 w 852"/>
              <a:gd name="T19" fmla="*/ 304 h 520"/>
              <a:gd name="T20" fmla="*/ 149 w 852"/>
              <a:gd name="T21" fmla="*/ 392 h 520"/>
              <a:gd name="T22" fmla="*/ 213 w 852"/>
              <a:gd name="T23" fmla="*/ 456 h 520"/>
              <a:gd name="T24" fmla="*/ 293 w 852"/>
              <a:gd name="T25" fmla="*/ 504 h 520"/>
              <a:gd name="T26" fmla="*/ 469 w 852"/>
              <a:gd name="T27" fmla="*/ 520 h 520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w 852"/>
              <a:gd name="T43" fmla="*/ 0 h 520"/>
              <a:gd name="T44" fmla="*/ 852 w 852"/>
              <a:gd name="T45" fmla="*/ 520 h 520"/>
            </a:gdLst>
            <a:ahLst/>
            <a:cxnLst>
              <a:cxn ang="T28">
                <a:pos x="T0" y="T1"/>
              </a:cxn>
              <a:cxn ang="T29">
                <a:pos x="T2" y="T3"/>
              </a:cxn>
              <a:cxn ang="T30">
                <a:pos x="T4" y="T5"/>
              </a:cxn>
              <a:cxn ang="T31">
                <a:pos x="T6" y="T7"/>
              </a:cxn>
              <a:cxn ang="T32">
                <a:pos x="T8" y="T9"/>
              </a:cxn>
              <a:cxn ang="T33">
                <a:pos x="T10" y="T11"/>
              </a:cxn>
              <a:cxn ang="T34">
                <a:pos x="T12" y="T13"/>
              </a:cxn>
              <a:cxn ang="T35">
                <a:pos x="T14" y="T15"/>
              </a:cxn>
              <a:cxn ang="T36">
                <a:pos x="T16" y="T17"/>
              </a:cxn>
              <a:cxn ang="T37">
                <a:pos x="T18" y="T19"/>
              </a:cxn>
              <a:cxn ang="T38">
                <a:pos x="T20" y="T21"/>
              </a:cxn>
              <a:cxn ang="T39">
                <a:pos x="T22" y="T23"/>
              </a:cxn>
              <a:cxn ang="T40">
                <a:pos x="T24" y="T25"/>
              </a:cxn>
              <a:cxn ang="T41">
                <a:pos x="T26" y="T27"/>
              </a:cxn>
            </a:cxnLst>
            <a:rect l="T42" t="T43" r="T44" b="T45"/>
            <a:pathLst>
              <a:path w="852" h="520">
                <a:moveTo>
                  <a:pt x="845" y="0"/>
                </a:moveTo>
                <a:cubicBezTo>
                  <a:pt x="848" y="31"/>
                  <a:pt x="852" y="62"/>
                  <a:pt x="845" y="80"/>
                </a:cubicBezTo>
                <a:cubicBezTo>
                  <a:pt x="838" y="98"/>
                  <a:pt x="829" y="100"/>
                  <a:pt x="805" y="112"/>
                </a:cubicBezTo>
                <a:cubicBezTo>
                  <a:pt x="781" y="124"/>
                  <a:pt x="745" y="144"/>
                  <a:pt x="701" y="152"/>
                </a:cubicBezTo>
                <a:cubicBezTo>
                  <a:pt x="657" y="160"/>
                  <a:pt x="605" y="159"/>
                  <a:pt x="541" y="160"/>
                </a:cubicBezTo>
                <a:cubicBezTo>
                  <a:pt x="477" y="161"/>
                  <a:pt x="376" y="159"/>
                  <a:pt x="317" y="160"/>
                </a:cubicBezTo>
                <a:cubicBezTo>
                  <a:pt x="258" y="161"/>
                  <a:pt x="230" y="160"/>
                  <a:pt x="189" y="168"/>
                </a:cubicBezTo>
                <a:cubicBezTo>
                  <a:pt x="148" y="176"/>
                  <a:pt x="100" y="196"/>
                  <a:pt x="69" y="208"/>
                </a:cubicBezTo>
                <a:cubicBezTo>
                  <a:pt x="38" y="220"/>
                  <a:pt x="10" y="224"/>
                  <a:pt x="5" y="240"/>
                </a:cubicBezTo>
                <a:cubicBezTo>
                  <a:pt x="0" y="256"/>
                  <a:pt x="13" y="279"/>
                  <a:pt x="37" y="304"/>
                </a:cubicBezTo>
                <a:cubicBezTo>
                  <a:pt x="61" y="329"/>
                  <a:pt x="120" y="367"/>
                  <a:pt x="149" y="392"/>
                </a:cubicBezTo>
                <a:cubicBezTo>
                  <a:pt x="178" y="417"/>
                  <a:pt x="189" y="437"/>
                  <a:pt x="213" y="456"/>
                </a:cubicBezTo>
                <a:cubicBezTo>
                  <a:pt x="237" y="475"/>
                  <a:pt x="250" y="493"/>
                  <a:pt x="293" y="504"/>
                </a:cubicBezTo>
                <a:cubicBezTo>
                  <a:pt x="336" y="515"/>
                  <a:pt x="402" y="517"/>
                  <a:pt x="469" y="520"/>
                </a:cubicBezTo>
              </a:path>
            </a:pathLst>
          </a:custGeom>
          <a:noFill/>
          <a:ln w="19050">
            <a:solidFill>
              <a:schemeClr val="tx2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77" name="AutoShape 122"/>
          <p:cNvSpPr>
            <a:spLocks/>
          </p:cNvSpPr>
          <p:nvPr/>
        </p:nvSpPr>
        <p:spPr bwMode="auto">
          <a:xfrm rot="16200001">
            <a:off x="2752811" y="-83391"/>
            <a:ext cx="213080" cy="3538823"/>
          </a:xfrm>
          <a:prstGeom prst="rightBracket">
            <a:avLst>
              <a:gd name="adj" fmla="val 136131"/>
            </a:avLst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78" name="AutoShape 124"/>
          <p:cNvSpPr>
            <a:spLocks/>
          </p:cNvSpPr>
          <p:nvPr/>
        </p:nvSpPr>
        <p:spPr bwMode="auto">
          <a:xfrm rot="16200001">
            <a:off x="6204731" y="256938"/>
            <a:ext cx="213080" cy="2858166"/>
          </a:xfrm>
          <a:prstGeom prst="rightBracket">
            <a:avLst>
              <a:gd name="adj" fmla="val 136131"/>
            </a:avLst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37931725" indent="-37474525"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endParaRPr lang="ja-JP" altLang="en-US"/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1124502" y="1268760"/>
            <a:ext cx="2978277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cystin-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5015391" y="1268760"/>
            <a:ext cx="2869994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cystin-2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7479940" y="4005064"/>
            <a:ext cx="1412540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acellula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7479940" y="4520153"/>
            <a:ext cx="1412540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cellula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フリーフォーム 182"/>
          <p:cNvSpPr/>
          <p:nvPr/>
        </p:nvSpPr>
        <p:spPr>
          <a:xfrm rot="21420534">
            <a:off x="886649" y="2258457"/>
            <a:ext cx="2458452" cy="1826040"/>
          </a:xfrm>
          <a:custGeom>
            <a:avLst/>
            <a:gdLst>
              <a:gd name="connsiteX0" fmla="*/ 746427 w 2425877"/>
              <a:gd name="connsiteY0" fmla="*/ 1333041 h 1333041"/>
              <a:gd name="connsiteX1" fmla="*/ 746427 w 2425877"/>
              <a:gd name="connsiteY1" fmla="*/ 1079653 h 1333041"/>
              <a:gd name="connsiteX2" fmla="*/ 944731 w 2425877"/>
              <a:gd name="connsiteY2" fmla="*/ 1013552 h 1333041"/>
              <a:gd name="connsiteX3" fmla="*/ 1087950 w 2425877"/>
              <a:gd name="connsiteY3" fmla="*/ 903383 h 1333041"/>
              <a:gd name="connsiteX4" fmla="*/ 1087950 w 2425877"/>
              <a:gd name="connsiteY4" fmla="*/ 815248 h 1333041"/>
              <a:gd name="connsiteX5" fmla="*/ 999815 w 2425877"/>
              <a:gd name="connsiteY5" fmla="*/ 782197 h 1333041"/>
              <a:gd name="connsiteX6" fmla="*/ 515073 w 2425877"/>
              <a:gd name="connsiteY6" fmla="*/ 859316 h 1333041"/>
              <a:gd name="connsiteX7" fmla="*/ 515073 w 2425877"/>
              <a:gd name="connsiteY7" fmla="*/ 716096 h 1333041"/>
              <a:gd name="connsiteX8" fmla="*/ 1462524 w 2425877"/>
              <a:gd name="connsiteY8" fmla="*/ 550843 h 1333041"/>
              <a:gd name="connsiteX9" fmla="*/ 1715912 w 2425877"/>
              <a:gd name="connsiteY9" fmla="*/ 572877 h 1333041"/>
              <a:gd name="connsiteX10" fmla="*/ 1837097 w 2425877"/>
              <a:gd name="connsiteY10" fmla="*/ 528810 h 1333041"/>
              <a:gd name="connsiteX11" fmla="*/ 1991333 w 2425877"/>
              <a:gd name="connsiteY11" fmla="*/ 451691 h 1333041"/>
              <a:gd name="connsiteX12" fmla="*/ 2299806 w 2425877"/>
              <a:gd name="connsiteY12" fmla="*/ 473725 h 1333041"/>
              <a:gd name="connsiteX13" fmla="*/ 2409974 w 2425877"/>
              <a:gd name="connsiteY13" fmla="*/ 396607 h 1333041"/>
              <a:gd name="connsiteX14" fmla="*/ 2409974 w 2425877"/>
              <a:gd name="connsiteY14" fmla="*/ 297455 h 1333041"/>
              <a:gd name="connsiteX15" fmla="*/ 2266755 w 2425877"/>
              <a:gd name="connsiteY15" fmla="*/ 253388 h 1333041"/>
              <a:gd name="connsiteX16" fmla="*/ 1980317 w 2425877"/>
              <a:gd name="connsiteY16" fmla="*/ 231354 h 1333041"/>
              <a:gd name="connsiteX17" fmla="*/ 1726929 w 2425877"/>
              <a:gd name="connsiteY17" fmla="*/ 242371 h 1333041"/>
              <a:gd name="connsiteX18" fmla="*/ 1352355 w 2425877"/>
              <a:gd name="connsiteY18" fmla="*/ 286438 h 1333041"/>
              <a:gd name="connsiteX19" fmla="*/ 878630 w 2425877"/>
              <a:gd name="connsiteY19" fmla="*/ 352540 h 1333041"/>
              <a:gd name="connsiteX20" fmla="*/ 647276 w 2425877"/>
              <a:gd name="connsiteY20" fmla="*/ 407624 h 1333041"/>
              <a:gd name="connsiteX21" fmla="*/ 515073 w 2425877"/>
              <a:gd name="connsiteY21" fmla="*/ 517793 h 1333041"/>
              <a:gd name="connsiteX22" fmla="*/ 272702 w 2425877"/>
              <a:gd name="connsiteY22" fmla="*/ 561860 h 1333041"/>
              <a:gd name="connsiteX23" fmla="*/ 74398 w 2425877"/>
              <a:gd name="connsiteY23" fmla="*/ 616944 h 1333041"/>
              <a:gd name="connsiteX24" fmla="*/ 8297 w 2425877"/>
              <a:gd name="connsiteY24" fmla="*/ 528810 h 1333041"/>
              <a:gd name="connsiteX25" fmla="*/ 19314 w 2425877"/>
              <a:gd name="connsiteY25" fmla="*/ 407624 h 1333041"/>
              <a:gd name="connsiteX26" fmla="*/ 173550 w 2425877"/>
              <a:gd name="connsiteY26" fmla="*/ 286438 h 1333041"/>
              <a:gd name="connsiteX27" fmla="*/ 614225 w 2425877"/>
              <a:gd name="connsiteY27" fmla="*/ 209320 h 1333041"/>
              <a:gd name="connsiteX28" fmla="*/ 735410 w 2425877"/>
              <a:gd name="connsiteY28" fmla="*/ 154236 h 1333041"/>
              <a:gd name="connsiteX29" fmla="*/ 988798 w 2425877"/>
              <a:gd name="connsiteY29" fmla="*/ 88135 h 1333041"/>
              <a:gd name="connsiteX30" fmla="*/ 1297271 w 2425877"/>
              <a:gd name="connsiteY30" fmla="*/ 0 h 1333041"/>
              <a:gd name="connsiteX31" fmla="*/ 1297271 w 2425877"/>
              <a:gd name="connsiteY31" fmla="*/ 0 h 13330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2425877" h="1333041">
                <a:moveTo>
                  <a:pt x="746427" y="1333041"/>
                </a:moveTo>
                <a:cubicBezTo>
                  <a:pt x="729901" y="1232971"/>
                  <a:pt x="713376" y="1132901"/>
                  <a:pt x="746427" y="1079653"/>
                </a:cubicBezTo>
                <a:cubicBezTo>
                  <a:pt x="779478" y="1026405"/>
                  <a:pt x="887811" y="1042930"/>
                  <a:pt x="944731" y="1013552"/>
                </a:cubicBezTo>
                <a:cubicBezTo>
                  <a:pt x="1001652" y="984174"/>
                  <a:pt x="1064080" y="936434"/>
                  <a:pt x="1087950" y="903383"/>
                </a:cubicBezTo>
                <a:cubicBezTo>
                  <a:pt x="1111820" y="870332"/>
                  <a:pt x="1102639" y="835446"/>
                  <a:pt x="1087950" y="815248"/>
                </a:cubicBezTo>
                <a:cubicBezTo>
                  <a:pt x="1073261" y="795050"/>
                  <a:pt x="1095294" y="774852"/>
                  <a:pt x="999815" y="782197"/>
                </a:cubicBezTo>
                <a:cubicBezTo>
                  <a:pt x="904336" y="789542"/>
                  <a:pt x="595863" y="870333"/>
                  <a:pt x="515073" y="859316"/>
                </a:cubicBezTo>
                <a:cubicBezTo>
                  <a:pt x="434283" y="848299"/>
                  <a:pt x="357165" y="767508"/>
                  <a:pt x="515073" y="716096"/>
                </a:cubicBezTo>
                <a:cubicBezTo>
                  <a:pt x="672981" y="664684"/>
                  <a:pt x="1262384" y="574713"/>
                  <a:pt x="1462524" y="550843"/>
                </a:cubicBezTo>
                <a:cubicBezTo>
                  <a:pt x="1662664" y="526973"/>
                  <a:pt x="1653483" y="576549"/>
                  <a:pt x="1715912" y="572877"/>
                </a:cubicBezTo>
                <a:cubicBezTo>
                  <a:pt x="1778341" y="569205"/>
                  <a:pt x="1791194" y="549008"/>
                  <a:pt x="1837097" y="528810"/>
                </a:cubicBezTo>
                <a:cubicBezTo>
                  <a:pt x="1883000" y="508612"/>
                  <a:pt x="1914215" y="460872"/>
                  <a:pt x="1991333" y="451691"/>
                </a:cubicBezTo>
                <a:cubicBezTo>
                  <a:pt x="2068451" y="442510"/>
                  <a:pt x="2230033" y="482906"/>
                  <a:pt x="2299806" y="473725"/>
                </a:cubicBezTo>
                <a:cubicBezTo>
                  <a:pt x="2369580" y="464544"/>
                  <a:pt x="2391613" y="425985"/>
                  <a:pt x="2409974" y="396607"/>
                </a:cubicBezTo>
                <a:cubicBezTo>
                  <a:pt x="2428335" y="367229"/>
                  <a:pt x="2433844" y="321325"/>
                  <a:pt x="2409974" y="297455"/>
                </a:cubicBezTo>
                <a:cubicBezTo>
                  <a:pt x="2386104" y="273585"/>
                  <a:pt x="2338364" y="264405"/>
                  <a:pt x="2266755" y="253388"/>
                </a:cubicBezTo>
                <a:cubicBezTo>
                  <a:pt x="2195146" y="242371"/>
                  <a:pt x="2070288" y="233190"/>
                  <a:pt x="1980317" y="231354"/>
                </a:cubicBezTo>
                <a:cubicBezTo>
                  <a:pt x="1890346" y="229518"/>
                  <a:pt x="1831589" y="233190"/>
                  <a:pt x="1726929" y="242371"/>
                </a:cubicBezTo>
                <a:cubicBezTo>
                  <a:pt x="1622269" y="251552"/>
                  <a:pt x="1352355" y="286438"/>
                  <a:pt x="1352355" y="286438"/>
                </a:cubicBezTo>
                <a:cubicBezTo>
                  <a:pt x="1210972" y="304800"/>
                  <a:pt x="996143" y="332342"/>
                  <a:pt x="878630" y="352540"/>
                </a:cubicBezTo>
                <a:cubicBezTo>
                  <a:pt x="761117" y="372738"/>
                  <a:pt x="707869" y="380082"/>
                  <a:pt x="647276" y="407624"/>
                </a:cubicBezTo>
                <a:cubicBezTo>
                  <a:pt x="586683" y="435166"/>
                  <a:pt x="577502" y="492087"/>
                  <a:pt x="515073" y="517793"/>
                </a:cubicBezTo>
                <a:cubicBezTo>
                  <a:pt x="452644" y="543499"/>
                  <a:pt x="346148" y="545335"/>
                  <a:pt x="272702" y="561860"/>
                </a:cubicBezTo>
                <a:cubicBezTo>
                  <a:pt x="199256" y="578385"/>
                  <a:pt x="118465" y="622452"/>
                  <a:pt x="74398" y="616944"/>
                </a:cubicBezTo>
                <a:cubicBezTo>
                  <a:pt x="30331" y="611436"/>
                  <a:pt x="17478" y="563697"/>
                  <a:pt x="8297" y="528810"/>
                </a:cubicBezTo>
                <a:cubicBezTo>
                  <a:pt x="-884" y="493923"/>
                  <a:pt x="-8228" y="448019"/>
                  <a:pt x="19314" y="407624"/>
                </a:cubicBezTo>
                <a:cubicBezTo>
                  <a:pt x="46856" y="367229"/>
                  <a:pt x="74398" y="319489"/>
                  <a:pt x="173550" y="286438"/>
                </a:cubicBezTo>
                <a:cubicBezTo>
                  <a:pt x="272702" y="253387"/>
                  <a:pt x="520582" y="231354"/>
                  <a:pt x="614225" y="209320"/>
                </a:cubicBezTo>
                <a:cubicBezTo>
                  <a:pt x="707868" y="187286"/>
                  <a:pt x="672981" y="174433"/>
                  <a:pt x="735410" y="154236"/>
                </a:cubicBezTo>
                <a:cubicBezTo>
                  <a:pt x="797839" y="134039"/>
                  <a:pt x="895155" y="113841"/>
                  <a:pt x="988798" y="88135"/>
                </a:cubicBezTo>
                <a:cubicBezTo>
                  <a:pt x="1082442" y="62429"/>
                  <a:pt x="1297271" y="0"/>
                  <a:pt x="1297271" y="0"/>
                </a:cubicBezTo>
                <a:lnTo>
                  <a:pt x="1297271" y="0"/>
                </a:lnTo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円/楕円 183"/>
          <p:cNvSpPr/>
          <p:nvPr/>
        </p:nvSpPr>
        <p:spPr>
          <a:xfrm rot="20830647">
            <a:off x="1357492" y="3748124"/>
            <a:ext cx="2685265" cy="1337453"/>
          </a:xfrm>
          <a:prstGeom prst="ellipse">
            <a:avLst/>
          </a:prstGeom>
          <a:noFill/>
          <a:ln w="9525">
            <a:solidFill>
              <a:srgbClr val="00B0F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5" name="フリーフォーム 184"/>
          <p:cNvSpPr/>
          <p:nvPr/>
        </p:nvSpPr>
        <p:spPr>
          <a:xfrm>
            <a:off x="762345" y="1792562"/>
            <a:ext cx="2661550" cy="2378209"/>
          </a:xfrm>
          <a:custGeom>
            <a:avLst/>
            <a:gdLst>
              <a:gd name="connsiteX0" fmla="*/ 107231 w 2661550"/>
              <a:gd name="connsiteY0" fmla="*/ 1892113 h 2270813"/>
              <a:gd name="connsiteX1" fmla="*/ 313420 w 2661550"/>
              <a:gd name="connsiteY1" fmla="*/ 2116230 h 2270813"/>
              <a:gd name="connsiteX2" fmla="*/ 528573 w 2661550"/>
              <a:gd name="connsiteY2" fmla="*/ 2205877 h 2270813"/>
              <a:gd name="connsiteX3" fmla="*/ 824408 w 2661550"/>
              <a:gd name="connsiteY3" fmla="*/ 2268630 h 2270813"/>
              <a:gd name="connsiteX4" fmla="*/ 985773 w 2661550"/>
              <a:gd name="connsiteY4" fmla="*/ 2232771 h 2270813"/>
              <a:gd name="connsiteX5" fmla="*/ 1075420 w 2661550"/>
              <a:gd name="connsiteY5" fmla="*/ 2017618 h 2270813"/>
              <a:gd name="connsiteX6" fmla="*/ 1362290 w 2661550"/>
              <a:gd name="connsiteY6" fmla="*/ 1676960 h 2270813"/>
              <a:gd name="connsiteX7" fmla="*/ 1936031 w 2661550"/>
              <a:gd name="connsiteY7" fmla="*/ 1479736 h 2270813"/>
              <a:gd name="connsiteX8" fmla="*/ 2384267 w 2661550"/>
              <a:gd name="connsiteY8" fmla="*/ 1354230 h 2270813"/>
              <a:gd name="connsiteX9" fmla="*/ 2635279 w 2661550"/>
              <a:gd name="connsiteY9" fmla="*/ 825313 h 2270813"/>
              <a:gd name="connsiteX10" fmla="*/ 2554596 w 2661550"/>
              <a:gd name="connsiteY10" fmla="*/ 197783 h 2270813"/>
              <a:gd name="connsiteX11" fmla="*/ 1756737 w 2661550"/>
              <a:gd name="connsiteY11" fmla="*/ 560 h 2270813"/>
              <a:gd name="connsiteX12" fmla="*/ 851302 w 2661550"/>
              <a:gd name="connsiteY12" fmla="*/ 242607 h 2270813"/>
              <a:gd name="connsiteX13" fmla="*/ 385137 w 2661550"/>
              <a:gd name="connsiteY13" fmla="*/ 592230 h 2270813"/>
              <a:gd name="connsiteX14" fmla="*/ 187914 w 2661550"/>
              <a:gd name="connsiteY14" fmla="*/ 807383 h 2270813"/>
              <a:gd name="connsiteX15" fmla="*/ 17584 w 2661550"/>
              <a:gd name="connsiteY15" fmla="*/ 1237689 h 2270813"/>
              <a:gd name="connsiteX16" fmla="*/ 17584 w 2661550"/>
              <a:gd name="connsiteY16" fmla="*/ 1641101 h 2270813"/>
              <a:gd name="connsiteX17" fmla="*/ 107231 w 2661550"/>
              <a:gd name="connsiteY17" fmla="*/ 1892113 h 22708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2661550" h="2270813">
                <a:moveTo>
                  <a:pt x="107231" y="1892113"/>
                </a:moveTo>
                <a:cubicBezTo>
                  <a:pt x="156537" y="1971301"/>
                  <a:pt x="243196" y="2063936"/>
                  <a:pt x="313420" y="2116230"/>
                </a:cubicBezTo>
                <a:cubicBezTo>
                  <a:pt x="383644" y="2168524"/>
                  <a:pt x="443408" y="2180477"/>
                  <a:pt x="528573" y="2205877"/>
                </a:cubicBezTo>
                <a:cubicBezTo>
                  <a:pt x="613738" y="2231277"/>
                  <a:pt x="748208" y="2264148"/>
                  <a:pt x="824408" y="2268630"/>
                </a:cubicBezTo>
                <a:cubicBezTo>
                  <a:pt x="900608" y="2273112"/>
                  <a:pt x="943938" y="2274606"/>
                  <a:pt x="985773" y="2232771"/>
                </a:cubicBezTo>
                <a:cubicBezTo>
                  <a:pt x="1027608" y="2190936"/>
                  <a:pt x="1012667" y="2110253"/>
                  <a:pt x="1075420" y="2017618"/>
                </a:cubicBezTo>
                <a:cubicBezTo>
                  <a:pt x="1138173" y="1924983"/>
                  <a:pt x="1218855" y="1766607"/>
                  <a:pt x="1362290" y="1676960"/>
                </a:cubicBezTo>
                <a:cubicBezTo>
                  <a:pt x="1505725" y="1587313"/>
                  <a:pt x="1765702" y="1533524"/>
                  <a:pt x="1936031" y="1479736"/>
                </a:cubicBezTo>
                <a:cubicBezTo>
                  <a:pt x="2106360" y="1425948"/>
                  <a:pt x="2267726" y="1463300"/>
                  <a:pt x="2384267" y="1354230"/>
                </a:cubicBezTo>
                <a:cubicBezTo>
                  <a:pt x="2500808" y="1245160"/>
                  <a:pt x="2606891" y="1018054"/>
                  <a:pt x="2635279" y="825313"/>
                </a:cubicBezTo>
                <a:cubicBezTo>
                  <a:pt x="2663667" y="632572"/>
                  <a:pt x="2701020" y="335242"/>
                  <a:pt x="2554596" y="197783"/>
                </a:cubicBezTo>
                <a:cubicBezTo>
                  <a:pt x="2408172" y="60324"/>
                  <a:pt x="2040619" y="-6911"/>
                  <a:pt x="1756737" y="560"/>
                </a:cubicBezTo>
                <a:cubicBezTo>
                  <a:pt x="1472855" y="8031"/>
                  <a:pt x="1079902" y="143995"/>
                  <a:pt x="851302" y="242607"/>
                </a:cubicBezTo>
                <a:cubicBezTo>
                  <a:pt x="622702" y="341219"/>
                  <a:pt x="495702" y="498101"/>
                  <a:pt x="385137" y="592230"/>
                </a:cubicBezTo>
                <a:cubicBezTo>
                  <a:pt x="274572" y="686359"/>
                  <a:pt x="249173" y="699806"/>
                  <a:pt x="187914" y="807383"/>
                </a:cubicBezTo>
                <a:cubicBezTo>
                  <a:pt x="126655" y="914960"/>
                  <a:pt x="45972" y="1098736"/>
                  <a:pt x="17584" y="1237689"/>
                </a:cubicBezTo>
                <a:cubicBezTo>
                  <a:pt x="-10804" y="1376642"/>
                  <a:pt x="-345" y="1529042"/>
                  <a:pt x="17584" y="1641101"/>
                </a:cubicBezTo>
                <a:cubicBezTo>
                  <a:pt x="35513" y="1753160"/>
                  <a:pt x="57925" y="1812925"/>
                  <a:pt x="107231" y="1892113"/>
                </a:cubicBezTo>
                <a:close/>
              </a:path>
            </a:pathLst>
          </a:custGeom>
          <a:noFill/>
          <a:ln w="9525">
            <a:solidFill>
              <a:schemeClr val="accent3">
                <a:lumMod val="75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3685275" y="2257125"/>
            <a:ext cx="1894837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S upstream dom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7" name="直線矢印コネクタ 186"/>
          <p:cNvCxnSpPr/>
          <p:nvPr/>
        </p:nvCxnSpPr>
        <p:spPr>
          <a:xfrm flipH="1">
            <a:off x="3466657" y="2411015"/>
            <a:ext cx="316437" cy="987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テキスト ボックス 187"/>
          <p:cNvSpPr txBox="1"/>
          <p:nvPr/>
        </p:nvSpPr>
        <p:spPr>
          <a:xfrm>
            <a:off x="899592" y="5137447"/>
            <a:ext cx="2130525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membrane dom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9" name="直線矢印コネクタ 188"/>
          <p:cNvCxnSpPr/>
          <p:nvPr/>
        </p:nvCxnSpPr>
        <p:spPr>
          <a:xfrm flipV="1">
            <a:off x="1475656" y="5013176"/>
            <a:ext cx="101777" cy="19297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テキスト ボックス 189"/>
          <p:cNvSpPr txBox="1"/>
          <p:nvPr/>
        </p:nvSpPr>
        <p:spPr>
          <a:xfrm>
            <a:off x="2369467" y="5589240"/>
            <a:ext cx="2130525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terminal tail dom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1" name="直線矢印コネクタ 190"/>
          <p:cNvCxnSpPr/>
          <p:nvPr/>
        </p:nvCxnSpPr>
        <p:spPr>
          <a:xfrm flipV="1">
            <a:off x="3995936" y="5445224"/>
            <a:ext cx="101777" cy="19297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フリーフォーム 191"/>
          <p:cNvSpPr/>
          <p:nvPr/>
        </p:nvSpPr>
        <p:spPr>
          <a:xfrm>
            <a:off x="3664856" y="4532490"/>
            <a:ext cx="2036162" cy="1264043"/>
          </a:xfrm>
          <a:custGeom>
            <a:avLst/>
            <a:gdLst>
              <a:gd name="connsiteX0" fmla="*/ 91356 w 2036162"/>
              <a:gd name="connsiteY0" fmla="*/ 541534 h 1264043"/>
              <a:gd name="connsiteX1" fmla="*/ 297544 w 2036162"/>
              <a:gd name="connsiteY1" fmla="*/ 765651 h 1264043"/>
              <a:gd name="connsiteX2" fmla="*/ 700956 w 2036162"/>
              <a:gd name="connsiteY2" fmla="*/ 1034592 h 1264043"/>
              <a:gd name="connsiteX3" fmla="*/ 1104368 w 2036162"/>
              <a:gd name="connsiteY3" fmla="*/ 1204922 h 1264043"/>
              <a:gd name="connsiteX4" fmla="*/ 1346415 w 2036162"/>
              <a:gd name="connsiteY4" fmla="*/ 1258710 h 1264043"/>
              <a:gd name="connsiteX5" fmla="*/ 1776720 w 2036162"/>
              <a:gd name="connsiteY5" fmla="*/ 1240781 h 1264043"/>
              <a:gd name="connsiteX6" fmla="*/ 2000838 w 2036162"/>
              <a:gd name="connsiteY6" fmla="*/ 1070451 h 1264043"/>
              <a:gd name="connsiteX7" fmla="*/ 2027732 w 2036162"/>
              <a:gd name="connsiteY7" fmla="*/ 944945 h 1264043"/>
              <a:gd name="connsiteX8" fmla="*/ 1920156 w 2036162"/>
              <a:gd name="connsiteY8" fmla="*/ 882192 h 1264043"/>
              <a:gd name="connsiteX9" fmla="*/ 1731897 w 2036162"/>
              <a:gd name="connsiteY9" fmla="*/ 900122 h 1264043"/>
              <a:gd name="connsiteX10" fmla="*/ 1525709 w 2036162"/>
              <a:gd name="connsiteY10" fmla="*/ 891157 h 1264043"/>
              <a:gd name="connsiteX11" fmla="*/ 1220909 w 2036162"/>
              <a:gd name="connsiteY11" fmla="*/ 882192 h 1264043"/>
              <a:gd name="connsiteX12" fmla="*/ 1095403 w 2036162"/>
              <a:gd name="connsiteY12" fmla="*/ 810475 h 1264043"/>
              <a:gd name="connsiteX13" fmla="*/ 521662 w 2036162"/>
              <a:gd name="connsiteY13" fmla="*/ 371204 h 1264043"/>
              <a:gd name="connsiteX14" fmla="*/ 440979 w 2036162"/>
              <a:gd name="connsiteY14" fmla="*/ 75369 h 1264043"/>
              <a:gd name="connsiteX15" fmla="*/ 405120 w 2036162"/>
              <a:gd name="connsiteY15" fmla="*/ 12616 h 1264043"/>
              <a:gd name="connsiteX16" fmla="*/ 288579 w 2036162"/>
              <a:gd name="connsiteY16" fmla="*/ 3651 h 1264043"/>
              <a:gd name="connsiteX17" fmla="*/ 154109 w 2036162"/>
              <a:gd name="connsiteY17" fmla="*/ 57439 h 1264043"/>
              <a:gd name="connsiteX18" fmla="*/ 37568 w 2036162"/>
              <a:gd name="connsiteY18" fmla="*/ 173981 h 1264043"/>
              <a:gd name="connsiteX19" fmla="*/ 1709 w 2036162"/>
              <a:gd name="connsiteY19" fmla="*/ 353275 h 1264043"/>
              <a:gd name="connsiteX20" fmla="*/ 91356 w 2036162"/>
              <a:gd name="connsiteY20" fmla="*/ 541534 h 12640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2036162" h="1264043">
                <a:moveTo>
                  <a:pt x="91356" y="541534"/>
                </a:moveTo>
                <a:cubicBezTo>
                  <a:pt x="140662" y="610263"/>
                  <a:pt x="195944" y="683475"/>
                  <a:pt x="297544" y="765651"/>
                </a:cubicBezTo>
                <a:cubicBezTo>
                  <a:pt x="399144" y="847827"/>
                  <a:pt x="566485" y="961380"/>
                  <a:pt x="700956" y="1034592"/>
                </a:cubicBezTo>
                <a:cubicBezTo>
                  <a:pt x="835427" y="1107804"/>
                  <a:pt x="996792" y="1167569"/>
                  <a:pt x="1104368" y="1204922"/>
                </a:cubicBezTo>
                <a:cubicBezTo>
                  <a:pt x="1211944" y="1242275"/>
                  <a:pt x="1234356" y="1252734"/>
                  <a:pt x="1346415" y="1258710"/>
                </a:cubicBezTo>
                <a:cubicBezTo>
                  <a:pt x="1458474" y="1264686"/>
                  <a:pt x="1667650" y="1272158"/>
                  <a:pt x="1776720" y="1240781"/>
                </a:cubicBezTo>
                <a:cubicBezTo>
                  <a:pt x="1885791" y="1209405"/>
                  <a:pt x="1959003" y="1119757"/>
                  <a:pt x="2000838" y="1070451"/>
                </a:cubicBezTo>
                <a:cubicBezTo>
                  <a:pt x="2042673" y="1021145"/>
                  <a:pt x="2041179" y="976321"/>
                  <a:pt x="2027732" y="944945"/>
                </a:cubicBezTo>
                <a:cubicBezTo>
                  <a:pt x="2014285" y="913569"/>
                  <a:pt x="1969462" y="889662"/>
                  <a:pt x="1920156" y="882192"/>
                </a:cubicBezTo>
                <a:cubicBezTo>
                  <a:pt x="1870850" y="874722"/>
                  <a:pt x="1797638" y="898628"/>
                  <a:pt x="1731897" y="900122"/>
                </a:cubicBezTo>
                <a:cubicBezTo>
                  <a:pt x="1666156" y="901616"/>
                  <a:pt x="1525709" y="891157"/>
                  <a:pt x="1525709" y="891157"/>
                </a:cubicBezTo>
                <a:cubicBezTo>
                  <a:pt x="1440544" y="888169"/>
                  <a:pt x="1292627" y="895639"/>
                  <a:pt x="1220909" y="882192"/>
                </a:cubicBezTo>
                <a:cubicBezTo>
                  <a:pt x="1149191" y="868745"/>
                  <a:pt x="1211944" y="895640"/>
                  <a:pt x="1095403" y="810475"/>
                </a:cubicBezTo>
                <a:cubicBezTo>
                  <a:pt x="978862" y="725310"/>
                  <a:pt x="630733" y="493722"/>
                  <a:pt x="521662" y="371204"/>
                </a:cubicBezTo>
                <a:cubicBezTo>
                  <a:pt x="412591" y="248686"/>
                  <a:pt x="460403" y="135134"/>
                  <a:pt x="440979" y="75369"/>
                </a:cubicBezTo>
                <a:cubicBezTo>
                  <a:pt x="421555" y="15604"/>
                  <a:pt x="430520" y="24569"/>
                  <a:pt x="405120" y="12616"/>
                </a:cubicBezTo>
                <a:cubicBezTo>
                  <a:pt x="379720" y="663"/>
                  <a:pt x="330414" y="-3819"/>
                  <a:pt x="288579" y="3651"/>
                </a:cubicBezTo>
                <a:cubicBezTo>
                  <a:pt x="246744" y="11121"/>
                  <a:pt x="195944" y="29051"/>
                  <a:pt x="154109" y="57439"/>
                </a:cubicBezTo>
                <a:cubicBezTo>
                  <a:pt x="112274" y="85827"/>
                  <a:pt x="62968" y="124675"/>
                  <a:pt x="37568" y="173981"/>
                </a:cubicBezTo>
                <a:cubicBezTo>
                  <a:pt x="12168" y="223287"/>
                  <a:pt x="-5761" y="290522"/>
                  <a:pt x="1709" y="353275"/>
                </a:cubicBezTo>
                <a:cubicBezTo>
                  <a:pt x="9179" y="416028"/>
                  <a:pt x="42050" y="472805"/>
                  <a:pt x="91356" y="541534"/>
                </a:cubicBez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3" name="右矢印 192"/>
          <p:cNvSpPr/>
          <p:nvPr/>
        </p:nvSpPr>
        <p:spPr>
          <a:xfrm rot="19858260" flipH="1" flipV="1">
            <a:off x="2060993" y="3256436"/>
            <a:ext cx="199865" cy="8012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2195736" y="3068960"/>
            <a:ext cx="857603" cy="276999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45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テキスト ボックス 194"/>
          <p:cNvSpPr txBox="1"/>
          <p:nvPr/>
        </p:nvSpPr>
        <p:spPr>
          <a:xfrm>
            <a:off x="235551" y="188640"/>
            <a:ext cx="18161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 eh.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右矢印 195"/>
          <p:cNvSpPr/>
          <p:nvPr/>
        </p:nvSpPr>
        <p:spPr>
          <a:xfrm rot="1563436">
            <a:off x="1550995" y="3601448"/>
            <a:ext cx="166482" cy="8324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755576" y="3429000"/>
            <a:ext cx="857603" cy="276999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7,97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36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95</TotalTime>
  <Words>132</Words>
  <Application>Microsoft Office PowerPoint</Application>
  <PresentationFormat>画面に合わせる (4:3)</PresentationFormat>
  <Paragraphs>77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東原　英二</dc:creator>
  <cp:lastModifiedBy>東原　英二</cp:lastModifiedBy>
  <cp:revision>400</cp:revision>
  <cp:lastPrinted>2017-02-24T05:19:20Z</cp:lastPrinted>
  <dcterms:created xsi:type="dcterms:W3CDTF">2015-10-31T08:08:45Z</dcterms:created>
  <dcterms:modified xsi:type="dcterms:W3CDTF">2017-08-08T06:51:13Z</dcterms:modified>
</cp:coreProperties>
</file>